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A5E94F-8618-BC74-2206-21A38D83F7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627B7A6-5FF8-CD6C-705D-D9ED612621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D8A304-8521-DDDA-2565-2CCFFEF9B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DF4E2A-3636-D598-8515-3C8B47CB0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7E110C-4DB1-077D-225B-AD9EA8198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793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78A21C-F508-46CE-6498-0E6895A40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98B704-4B7C-54C1-B941-CD07CAA7D5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71A1AA-9065-C2B5-81B0-60BE1FF1B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03AE39-7D96-67F8-3251-1B368F54E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D72E7A-6B7F-BFE2-F19E-9EAB0D06D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699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7FEDC6D-1FF9-F1BA-C003-BDD0C474AC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B060031-77DF-5FD7-A90B-E7BFF7E1CF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FBC1C9-4F07-BBCC-2787-6094F4580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50CAB6C-1000-1C58-0A49-A00F4EC7A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38E5C8-089D-D51B-E29C-47CA8E8A7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3815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BF6DA6-22A1-723A-6D9C-2DE29BD061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4DDD9A-12F8-B071-7176-C603ECC09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EE8F24-C4DD-8905-1479-258BEA015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04DA34-309B-1C6A-A70D-931D05659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157C55-C1D8-0AF2-ACF5-3518135A3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928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F3CFF8-2A96-EF5A-032D-F51D0E340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48D72A-05FB-EE6B-3469-AC09167190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CCBA50-56E8-D8CF-C8AF-A038F8DEB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20ACF9-32B4-9D37-74B7-A9C650863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B9DC53-2986-A669-61B2-F5E24CC2C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481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7329A9-698C-B2E4-0132-A2BBBCCAB8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277463D-B479-46E6-5103-25671737E2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3CEFE4-7309-88EE-2235-75255F2D72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12DA08-599A-84F9-A1CA-46F0C8B43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23627A-5A06-57FE-B58C-A3A8734D3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E68807B-305A-36BF-CF79-0A030753C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5854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633D5C-2E76-61F7-4038-B143971A67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381A63-6A67-F203-AEFA-39437410C2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726C13-80C3-5D1B-A120-684C7485DC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3F93BED-C34E-60FC-5100-75E2332D6A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75D44D2-996B-0E56-9599-60C1AA5DE8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7163D9B-648B-3DCD-3BD0-7A743046B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B638140-6071-0D16-D718-67D361411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40A5043-238E-E51C-D81F-7199F91D2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073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6DBCD9-88E7-C6F8-6E98-1F5A0CA691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77692BF-FF7D-0D32-C7B5-B18345B7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0186AC-AD4D-9C00-EE72-91CA56243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3F8B7CF-69F0-4A26-2B40-CA71D8173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244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DCE3A82-3D63-5141-7B74-BF657795F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E5788D8-6C06-B17B-6F75-7BD9D28FE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42F3349-7CDF-5B60-A887-832EBEB6A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5968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2F5577-7E4A-D464-8369-23D0345EB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BE42E4-A3A3-ABAC-F756-F9297FBE2D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3B9C69B-696A-4AF7-4932-EF303AC593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54E544-4083-F7C3-DA4E-A71B2AD4F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32AA0BD-0527-4B93-EE39-136B0DEBE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D1FDF0-7162-1ECB-48B6-83E781EEA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3055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B3DEE7-74E1-6281-BD51-2D53FE901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2172403-6EBE-BF50-ADC7-305E2D50FA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79308A7-72D7-9A8B-829E-2707A996D3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C89DF35-1240-A579-9560-7C4229764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A1532C-4A39-8CC2-6CAF-18DB75941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09BC9D-2A1D-6D1F-53F3-2E7CA388D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3498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4A26354-B8A3-1613-B723-AE52C77D3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BD6A54-1CE4-DCA4-241A-E04B5CF0B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46DE27-83E7-2A9E-65C8-C28430A66A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5E457-5C4E-4DF8-993A-747D0EDE0AEB}" type="datetimeFigureOut">
              <a:rPr lang="zh-CN" altLang="en-US" smtClean="0"/>
              <a:t>2022/1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929C02-EF72-70C6-A0A2-88B8921CE9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9B4234-D73E-3B2D-C967-913A5CF4E2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B9F55-D6FE-4320-B23B-B8936D8DD8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394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B1B9DA1-39CB-D71C-2417-D36EEB8AC0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112" y="755780"/>
            <a:ext cx="7627775" cy="610222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73A2149-D23B-C6D6-B8B2-7663B3BC612F}"/>
              </a:ext>
            </a:extLst>
          </p:cNvPr>
          <p:cNvSpPr txBox="1"/>
          <p:nvPr/>
        </p:nvSpPr>
        <p:spPr>
          <a:xfrm>
            <a:off x="1175658" y="88641"/>
            <a:ext cx="93492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ojected SARS-CoV-2 Omicron infection burden in China in scenarios with more initial infections compared with that at baseline period (20 vs 5)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8482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A04D5DC-51F6-801F-6ADE-2C6C0637E4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909" y="362628"/>
            <a:ext cx="9144019" cy="548641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88E9EB2-CE5E-CD09-5640-BCC771356AA0}"/>
              </a:ext>
            </a:extLst>
          </p:cNvPr>
          <p:cNvSpPr txBox="1"/>
          <p:nvPr/>
        </p:nvSpPr>
        <p:spPr>
          <a:xfrm>
            <a:off x="354563" y="39463"/>
            <a:ext cx="107581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Daily cases of infection caused by SARS-CoV-2 Omicron variant in Macau 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A45A198-1E01-6ACE-0EFB-A49F558453E5}"/>
              </a:ext>
            </a:extLst>
          </p:cNvPr>
          <p:cNvSpPr txBox="1"/>
          <p:nvPr/>
        </p:nvSpPr>
        <p:spPr>
          <a:xfrm>
            <a:off x="242596" y="5725671"/>
            <a:ext cx="12204441" cy="8930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ote: NPIIL: nonpharmaceutical intervention intensity level</a:t>
            </a:r>
            <a:endParaRPr lang="zh-CN" altLang="zh-CN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PIILs between 0 and 1. NPIII level 0.1 indicates that the strictest NPI was carried out, while NPIII level 1 indicated that </a:t>
            </a:r>
            <a:r>
              <a:rPr lang="en-US" altLang="zh-CN" sz="1400" kern="100" dirty="0">
                <a:solidFill>
                  <a:srgbClr val="2F2A26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o NPI was implemented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05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5068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B373FA9-FBCD-0290-2FC9-93B3076783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151" y="706535"/>
            <a:ext cx="9227197" cy="615146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7F4666B-9BB6-BC38-A271-984D4DC93DE1}"/>
              </a:ext>
            </a:extLst>
          </p:cNvPr>
          <p:cNvSpPr txBox="1"/>
          <p:nvPr/>
        </p:nvSpPr>
        <p:spPr>
          <a:xfrm>
            <a:off x="625151" y="0"/>
            <a:ext cx="105156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ediction of SARS-CoV-2 Omicron burden using different NPIILs of NPI mitigation strategies at specific timepoints among different age groups based on the positive scenario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1B0001B-7284-FB67-6029-C8B55CFD34D7}"/>
              </a:ext>
            </a:extLst>
          </p:cNvPr>
          <p:cNvSpPr txBox="1"/>
          <p:nvPr/>
        </p:nvSpPr>
        <p:spPr>
          <a:xfrm>
            <a:off x="9852348" y="923330"/>
            <a:ext cx="2109497" cy="5217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lvl="0" indent="-342900" algn="just">
              <a:lnSpc>
                <a:spcPct val="200000"/>
              </a:lnSpc>
              <a:buFont typeface="+mj-lt"/>
              <a:buAutoNum type="alphaUcPeriod"/>
            </a:pP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urrent number of </a:t>
            </a:r>
            <a:r>
              <a:rPr lang="en-US" altLang="zh-CN" sz="1050" kern="100" dirty="0">
                <a:solidFill>
                  <a:srgbClr val="2F2A26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CU </a:t>
            </a: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atients per 10,000 individuals</a:t>
            </a:r>
            <a:endParaRPr lang="zh-CN" altLang="zh-CN" sz="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lphaUcPeriod"/>
            </a:pP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aily number of infectious cases per 10,000 individuals</a:t>
            </a:r>
            <a:endParaRPr lang="zh-CN" altLang="zh-CN" sz="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lphaUcPeriod"/>
            </a:pP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aily number of deaths per 10,000 individuals</a:t>
            </a:r>
            <a:endParaRPr lang="zh-CN" altLang="zh-CN" sz="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+mj-lt"/>
              <a:buAutoNum type="alphaUcPeriod"/>
            </a:pP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urrent number of non-ICU patients per 10,000 individuals</a:t>
            </a:r>
            <a:endParaRPr lang="zh-CN" altLang="zh-CN" sz="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A, the red dashed line indicates the number of ICU beds available in China. All data are presented as median with 2.5% and 97.5% quantiles of n=200 simulations.</a:t>
            </a:r>
            <a:endParaRPr lang="zh-CN" altLang="zh-CN" sz="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105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CU, intensive care unit</a:t>
            </a:r>
            <a:endParaRPr lang="zh-CN" altLang="zh-CN" sz="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4082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7</Words>
  <Application>Microsoft Office PowerPoint</Application>
  <PresentationFormat>宽屏</PresentationFormat>
  <Paragraphs>1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aocanfly</dc:creator>
  <cp:lastModifiedBy>miaocanfly</cp:lastModifiedBy>
  <cp:revision>3</cp:revision>
  <dcterms:created xsi:type="dcterms:W3CDTF">2022-12-21T16:23:18Z</dcterms:created>
  <dcterms:modified xsi:type="dcterms:W3CDTF">2022-12-21T16:45:05Z</dcterms:modified>
</cp:coreProperties>
</file>